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637" r:id="rId2"/>
    <p:sldId id="643" r:id="rId3"/>
    <p:sldId id="642" r:id="rId4"/>
  </p:sldIdLst>
  <p:sldSz cx="6858000" cy="9144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2A765"/>
    <a:srgbClr val="34411B"/>
    <a:srgbClr val="2E3917"/>
    <a:srgbClr val="0000FF"/>
    <a:srgbClr val="3A21CF"/>
    <a:srgbClr val="4D0EFE"/>
    <a:srgbClr val="FF99FF"/>
    <a:srgbClr val="FF5050"/>
    <a:srgbClr val="FF00FF"/>
    <a:srgbClr val="CC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22838BEF-8BB2-4498-84A7-C5851F593DF1}" styleName="Medium Style 4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5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5">
              <a:tint val="20000"/>
            </a:schemeClr>
          </a:solidFill>
        </a:fill>
      </a:tcStyle>
    </a:firstRow>
  </a:tblStyle>
  <a:tblStyle styleId="{C4B1156A-380E-4F78-BDF5-A606A8083BF9}" styleName="Medium Style 4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8A107856-5554-42FB-B03E-39F5DBC370BA}" styleName="Medium Style 4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912C8C85-51F0-491E-9774-3900AFEF0FD7}" styleName="Light Style 2 - Accent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638B1855-1B75-4FBE-930C-398BA8C253C6}" styleName="Themed Style 2 - Accent 6">
    <a:tblBg>
      <a:fillRef idx="3">
        <a:schemeClr val="accent6"/>
      </a:fillRef>
      <a:effectRef idx="3">
        <a:schemeClr val="accent6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6">
                <a:tint val="50000"/>
              </a:schemeClr>
            </a:lnRef>
          </a:left>
          <a:right>
            <a:lnRef idx="1">
              <a:schemeClr val="accent6">
                <a:tint val="50000"/>
              </a:schemeClr>
            </a:lnRef>
          </a:right>
          <a:top>
            <a:lnRef idx="1">
              <a:schemeClr val="accent6">
                <a:tint val="50000"/>
              </a:schemeClr>
            </a:lnRef>
          </a:top>
          <a:bottom>
            <a:lnRef idx="1">
              <a:schemeClr val="accent6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327F97BB-C833-4FB7-BDE5-3F7075034690}" styleName="Themed Style 2 - Accent 5">
    <a:tblBg>
      <a:fillRef idx="3">
        <a:schemeClr val="accent5"/>
      </a:fillRef>
      <a:effectRef idx="3">
        <a:schemeClr val="accent5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5">
                <a:tint val="50000"/>
              </a:schemeClr>
            </a:lnRef>
          </a:left>
          <a:right>
            <a:lnRef idx="1">
              <a:schemeClr val="accent5">
                <a:tint val="50000"/>
              </a:schemeClr>
            </a:lnRef>
          </a:right>
          <a:top>
            <a:lnRef idx="1">
              <a:schemeClr val="accent5">
                <a:tint val="50000"/>
              </a:schemeClr>
            </a:lnRef>
          </a:top>
          <a:bottom>
            <a:lnRef idx="1">
              <a:schemeClr val="accent5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E269D01E-BC32-4049-B463-5C60D7B0CCD2}" styleName="Themed Style 2 - Accent 4">
    <a:tblBg>
      <a:fillRef idx="3">
        <a:schemeClr val="accent4"/>
      </a:fillRef>
      <a:effectRef idx="3">
        <a:schemeClr val="accent4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4">
                <a:tint val="50000"/>
              </a:schemeClr>
            </a:lnRef>
          </a:left>
          <a:right>
            <a:lnRef idx="1">
              <a:schemeClr val="accent4">
                <a:tint val="50000"/>
              </a:schemeClr>
            </a:lnRef>
          </a:right>
          <a:top>
            <a:lnRef idx="1">
              <a:schemeClr val="accent4">
                <a:tint val="50000"/>
              </a:schemeClr>
            </a:lnRef>
          </a:top>
          <a:bottom>
            <a:lnRef idx="1">
              <a:schemeClr val="accent4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18603FDC-E32A-4AB5-989C-0864C3EAD2B8}" styleName="Themed Style 2 - Accent 2">
    <a:tblBg>
      <a:fillRef idx="3">
        <a:schemeClr val="accent2"/>
      </a:fillRef>
      <a:effectRef idx="3">
        <a:schemeClr val="accent2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2">
                <a:tint val="50000"/>
              </a:schemeClr>
            </a:lnRef>
          </a:left>
          <a:right>
            <a:lnRef idx="1">
              <a:schemeClr val="accent2">
                <a:tint val="50000"/>
              </a:schemeClr>
            </a:lnRef>
          </a:right>
          <a:top>
            <a:lnRef idx="1">
              <a:schemeClr val="accent2">
                <a:tint val="50000"/>
              </a:schemeClr>
            </a:lnRef>
          </a:top>
          <a:bottom>
            <a:lnRef idx="1">
              <a:schemeClr val="accent2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D113A9D2-9D6B-4929-AA2D-F23B5EE8CBE7}" styleName="Themed Style 2 - Accent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082" autoAdjust="0"/>
    <p:restoredTop sz="94172" autoAdjust="0"/>
  </p:normalViewPr>
  <p:slideViewPr>
    <p:cSldViewPr>
      <p:cViewPr>
        <p:scale>
          <a:sx n="75" d="100"/>
          <a:sy n="75" d="100"/>
        </p:scale>
        <p:origin x="-3756" y="-24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900"/>
    </p:cViewPr>
  </p:sorterViewPr>
  <p:notesViewPr>
    <p:cSldViewPr showGuides="1">
      <p:cViewPr varScale="1">
        <p:scale>
          <a:sx n="82" d="100"/>
          <a:sy n="82" d="100"/>
        </p:scale>
        <p:origin x="-3780" y="-96"/>
      </p:cViewPr>
      <p:guideLst>
        <p:guide orient="horz" pos="3024"/>
        <p:guide pos="2304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375" y="0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10C42E-E7F4-42D1-B864-0CB93E2FB6C8}" type="datetimeFigureOut">
              <a:rPr lang="en-US" smtClean="0"/>
              <a:pPr/>
              <a:t>8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20188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846320" y="9120188"/>
            <a:ext cx="3170238" cy="4794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DC4227-FAAB-447F-85D6-730813F60035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33714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D8EBE152-F051-40CC-B8D1-6F11D1CA6F7A}" type="datetimeFigureOut">
              <a:rPr lang="en-US" smtClean="0"/>
              <a:pPr/>
              <a:t>8/22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6638" y="720725"/>
            <a:ext cx="2701925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0"/>
            <a:ext cx="5852160" cy="4320540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0060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CE26B62F-9DF2-48FE-9CC2-DF278E7A1433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3215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40CCFE-A627-4DEC-BEE0-E1CB91828B3F}" type="datetime1">
              <a:rPr lang="en-US" smtClean="0"/>
              <a:pPr/>
              <a:t>8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5883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D32278-0D45-4725-8C01-04CEED69D0C1}" type="datetime1">
              <a:rPr lang="en-US" smtClean="0"/>
              <a:pPr/>
              <a:t>8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5908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08059-2E0D-4FD4-8CE9-FE1E9A4BBFE2}" type="datetime1">
              <a:rPr lang="en-US" smtClean="0"/>
              <a:pPr/>
              <a:t>8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409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CA10B-59F9-4C54-94F4-2C4E4232E0CF}" type="datetime1">
              <a:rPr lang="en-US" smtClean="0"/>
              <a:pPr/>
              <a:t>8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453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2A067-C4D7-40B4-AED5-64BA96B14E81}" type="datetime1">
              <a:rPr lang="en-US" smtClean="0"/>
              <a:pPr/>
              <a:t>8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886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CA72F1-559C-40B7-8706-1E0F6F2BA533}" type="datetime1">
              <a:rPr lang="en-US" smtClean="0"/>
              <a:pPr/>
              <a:t>8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0678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BE0C7A-11B0-4293-BF3C-F1F17E46639C}" type="datetime1">
              <a:rPr lang="en-US" smtClean="0"/>
              <a:pPr/>
              <a:t>8/2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474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495E4-5A9F-4A3A-A114-B2276AF36280}" type="datetime1">
              <a:rPr lang="en-US" smtClean="0"/>
              <a:pPr/>
              <a:t>8/2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612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B67E30-17CE-412C-A5AC-C5339C867472}" type="datetime1">
              <a:rPr lang="en-US" smtClean="0"/>
              <a:pPr/>
              <a:t>8/2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6788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3EB5C-4587-4D37-A8BE-96F44F4782AD}" type="datetime1">
              <a:rPr lang="en-US" smtClean="0"/>
              <a:pPr/>
              <a:t>8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932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9ECECD-056A-475A-9956-D707866B37D5}" type="datetime1">
              <a:rPr lang="en-US" smtClean="0"/>
              <a:pPr/>
              <a:t>8/2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253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0F96A2-CC89-4D24-AE65-56D640D21B64}" type="datetime1">
              <a:rPr lang="en-US" smtClean="0"/>
              <a:pPr/>
              <a:t>8/2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CA62C2-8D3F-439D-94AC-C26847FF0122}" type="slidenum">
              <a:rPr lang="en-US" smtClean="0"/>
              <a:pPr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0443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1</a:t>
            </a:fld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647700" y="4267200"/>
            <a:ext cx="5867400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Tissue classification based on CellNet analysis.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 has been performed using the .CEL files of undifferentiated H9 ESCs, foreskin hiPSCs and IMR90 hiPSCs (day 0) as well as the differentiated cells (day 14)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Although the tissue classification scores were &lt;0.2, hESCs and hiPSCs revealed an increase in score during differentiation (day 14)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s compared to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day 0. In addition, higher tissue classification scores for neuron, fibroblast, lung, skin and heart tissue were found in the IMR90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iPSCs as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compare to Foreskin </a:t>
            </a:r>
            <a:r>
              <a:rPr lang="en-GB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iPSCs and the H9 ESCs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843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685800"/>
            <a:ext cx="5656055" cy="35253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999428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2</a:t>
            </a:fld>
            <a:endParaRPr lang="en-US"/>
          </a:p>
        </p:txBody>
      </p:sp>
      <p:grpSp>
        <p:nvGrpSpPr>
          <p:cNvPr id="31" name="Group 30"/>
          <p:cNvGrpSpPr/>
          <p:nvPr/>
        </p:nvGrpSpPr>
        <p:grpSpPr>
          <a:xfrm>
            <a:off x="381000" y="838200"/>
            <a:ext cx="6289964" cy="3421707"/>
            <a:chOff x="152400" y="3276600"/>
            <a:chExt cx="6289964" cy="3421707"/>
          </a:xfrm>
        </p:grpSpPr>
        <p:grpSp>
          <p:nvGrpSpPr>
            <p:cNvPr id="25" name="Group 24"/>
            <p:cNvGrpSpPr/>
            <p:nvPr/>
          </p:nvGrpSpPr>
          <p:grpSpPr>
            <a:xfrm>
              <a:off x="152400" y="3276600"/>
              <a:ext cx="6289964" cy="3421707"/>
              <a:chOff x="228600" y="3276600"/>
              <a:chExt cx="6289964" cy="3421707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228600" y="3276600"/>
                <a:ext cx="6289964" cy="3421707"/>
                <a:chOff x="228600" y="3276600"/>
                <a:chExt cx="6289964" cy="3421707"/>
              </a:xfrm>
            </p:grpSpPr>
            <p:grpSp>
              <p:nvGrpSpPr>
                <p:cNvPr id="4" name="Group 3"/>
                <p:cNvGrpSpPr/>
                <p:nvPr/>
              </p:nvGrpSpPr>
              <p:grpSpPr>
                <a:xfrm>
                  <a:off x="228600" y="3276600"/>
                  <a:ext cx="6289964" cy="3200400"/>
                  <a:chOff x="228600" y="3276600"/>
                  <a:chExt cx="6289964" cy="3200400"/>
                </a:xfrm>
              </p:grpSpPr>
              <p:pic>
                <p:nvPicPr>
                  <p:cNvPr id="9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28600" y="3276600"/>
                    <a:ext cx="6289964" cy="320040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11" name="Oval 10"/>
                  <p:cNvSpPr/>
                  <p:nvPr/>
                </p:nvSpPr>
                <p:spPr>
                  <a:xfrm>
                    <a:off x="5410200" y="4486275"/>
                    <a:ext cx="381000" cy="381000"/>
                  </a:xfrm>
                  <a:prstGeom prst="ellipse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2" name="Oval 11"/>
                  <p:cNvSpPr/>
                  <p:nvPr/>
                </p:nvSpPr>
                <p:spPr>
                  <a:xfrm>
                    <a:off x="3657600" y="5791200"/>
                    <a:ext cx="609600" cy="381000"/>
                  </a:xfrm>
                  <a:prstGeom prst="ellipse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3" name="Oval 12"/>
                  <p:cNvSpPr/>
                  <p:nvPr/>
                </p:nvSpPr>
                <p:spPr>
                  <a:xfrm>
                    <a:off x="2971800" y="5257800"/>
                    <a:ext cx="609600" cy="685800"/>
                  </a:xfrm>
                  <a:prstGeom prst="ellipse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4" name="Oval 13"/>
                  <p:cNvSpPr/>
                  <p:nvPr/>
                </p:nvSpPr>
                <p:spPr>
                  <a:xfrm>
                    <a:off x="1410283" y="4800600"/>
                    <a:ext cx="951917" cy="685800"/>
                  </a:xfrm>
                  <a:prstGeom prst="ellipse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5" name="Oval 14"/>
                  <p:cNvSpPr/>
                  <p:nvPr/>
                </p:nvSpPr>
                <p:spPr>
                  <a:xfrm>
                    <a:off x="812462" y="4419600"/>
                    <a:ext cx="787738" cy="533400"/>
                  </a:xfrm>
                  <a:prstGeom prst="ellipse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16" name="Oval 15"/>
                  <p:cNvSpPr/>
                  <p:nvPr/>
                </p:nvSpPr>
                <p:spPr>
                  <a:xfrm>
                    <a:off x="2819400" y="3505200"/>
                    <a:ext cx="1143000" cy="457200"/>
                  </a:xfrm>
                  <a:prstGeom prst="ellipse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17" name="TextBox 16"/>
                <p:cNvSpPr txBox="1"/>
                <p:nvPr/>
              </p:nvSpPr>
              <p:spPr>
                <a:xfrm rot="16200000">
                  <a:off x="-341307" y="4898128"/>
                  <a:ext cx="163077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C2 20.8%</a:t>
                  </a:r>
                  <a:endParaRPr 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2404404" y="6390530"/>
                  <a:ext cx="197299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4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C 1 31.3%</a:t>
                  </a:r>
                  <a:endParaRPr lang="en-US" sz="14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9" name="TextBox 18"/>
              <p:cNvSpPr txBox="1"/>
              <p:nvPr/>
            </p:nvSpPr>
            <p:spPr>
              <a:xfrm>
                <a:off x="2743200" y="3945493"/>
                <a:ext cx="132866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9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ESCs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,  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 14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572000" y="4600545"/>
                <a:ext cx="9334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9 </a:t>
                </a:r>
                <a:r>
                  <a:rPr lang="en-US" sz="10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ESCs</a:t>
                </a:r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,  </a:t>
                </a:r>
                <a:endParaRPr lang="en-US" sz="10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 0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219200" y="5468779"/>
                <a:ext cx="1328662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oreskin </a:t>
                </a:r>
                <a:r>
                  <a:rPr lang="en-US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iPSCs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, 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 14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3715400" y="5524499"/>
                <a:ext cx="16764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oreskin </a:t>
                </a:r>
                <a:r>
                  <a:rPr lang="en-US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iPSCs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, 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 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933159" y="3962400"/>
                <a:ext cx="1200441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MR90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iPSCs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 14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895600" y="4889223"/>
                <a:ext cx="1481796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MR90 </a:t>
                </a:r>
                <a:r>
                  <a:rPr lang="en-US" sz="10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iPPSCs</a:t>
                </a:r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; </a:t>
                </a:r>
                <a:endPara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 0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" name="Group 29"/>
            <p:cNvGrpSpPr/>
            <p:nvPr/>
          </p:nvGrpSpPr>
          <p:grpSpPr>
            <a:xfrm>
              <a:off x="3048000" y="4401979"/>
              <a:ext cx="1981200" cy="429399"/>
              <a:chOff x="3048000" y="4401979"/>
              <a:chExt cx="1981200" cy="429399"/>
            </a:xfrm>
          </p:grpSpPr>
          <p:sp>
            <p:nvSpPr>
              <p:cNvPr id="26" name="Oval 25"/>
              <p:cNvSpPr/>
              <p:nvPr/>
            </p:nvSpPr>
            <p:spPr>
              <a:xfrm>
                <a:off x="3051792" y="4472375"/>
                <a:ext cx="114300" cy="99625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Oval 26"/>
              <p:cNvSpPr/>
              <p:nvPr/>
            </p:nvSpPr>
            <p:spPr>
              <a:xfrm>
                <a:off x="3048000" y="4624775"/>
                <a:ext cx="114300" cy="99625"/>
              </a:xfrm>
              <a:prstGeom prst="ellipse">
                <a:avLst/>
              </a:prstGeom>
              <a:solidFill>
                <a:srgbClr val="2E3917"/>
              </a:solidFill>
              <a:ln>
                <a:solidFill>
                  <a:srgbClr val="34411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3124200" y="4401979"/>
                <a:ext cx="19050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VPA </a:t>
                </a:r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reatment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3124200" y="4554379"/>
                <a:ext cx="13716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Vehicle control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2" name="Rectangle 31"/>
          <p:cNvSpPr/>
          <p:nvPr/>
        </p:nvSpPr>
        <p:spPr>
          <a:xfrm>
            <a:off x="457200" y="4267200"/>
            <a:ext cx="6096000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GB" sz="1100" b="1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. Human embryonic stem cells (hESCs; H9) and human induced pluripotent stem cells (hiPSCs; IMR90, Foreskin) were differentiated for 14 days, exposed to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1 mM VPA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during differentiation and samples on day 0 and day 14 were collected as indicated in Fig. 1A and used for whole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transcriptome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analysis. The data structure of all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transcriptome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data sets was dimensionality-reduced and presented in the form of a 2D-principle component analysis (PCA) diagram. The PCA illustrates a relatively large distance between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hESCs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and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hiPSCs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on day 0 indicating initial differences in </a:t>
            </a:r>
            <a:r>
              <a:rPr lang="en-GB" sz="1100" dirty="0" err="1" smtClean="0">
                <a:latin typeface="Arial" pitchFamily="34" charset="0"/>
                <a:cs typeface="Arial" pitchFamily="34" charset="0"/>
              </a:rPr>
              <a:t>transcriptomes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 profile, however 14 days differentiation resulted in large distance between day0 and day14 in all and direction of change observed similar amongst them along PC1.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Up Arrow 4"/>
          <p:cNvSpPr/>
          <p:nvPr/>
        </p:nvSpPr>
        <p:spPr>
          <a:xfrm rot="17707387" flipH="1">
            <a:off x="4755481" y="1047369"/>
            <a:ext cx="205838" cy="1501117"/>
          </a:xfrm>
          <a:prstGeom prst="up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8" name="Up Arrow 37"/>
          <p:cNvSpPr/>
          <p:nvPr/>
        </p:nvSpPr>
        <p:spPr>
          <a:xfrm rot="17707387" flipH="1">
            <a:off x="2305201" y="1535185"/>
            <a:ext cx="232334" cy="1776972"/>
          </a:xfrm>
          <a:prstGeom prst="up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9" name="Up Arrow 38"/>
          <p:cNvSpPr/>
          <p:nvPr/>
        </p:nvSpPr>
        <p:spPr>
          <a:xfrm rot="17707387" flipH="1">
            <a:off x="3160623" y="2302036"/>
            <a:ext cx="221975" cy="1568126"/>
          </a:xfrm>
          <a:prstGeom prst="upArrow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6119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CA62C2-8D3F-439D-94AC-C26847FF0122}" type="slidenum">
              <a:rPr lang="en-US" smtClean="0"/>
              <a:pPr/>
              <a:t>3</a:t>
            </a:fld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381000" y="4010561"/>
            <a:ext cx="6019800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GB" sz="1100" b="1" dirty="0" smtClean="0">
                <a:latin typeface="Arial" pitchFamily="34" charset="0"/>
                <a:cs typeface="Arial" pitchFamily="34" charset="0"/>
              </a:rPr>
              <a:t>3.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Overlap analysis of “developmental” PS in H9 hESCs, IMR90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and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Foreskin hiPSCs (D-PS; FC ≥± 5, p &lt;0.05) deregulated by VPA.</a:t>
            </a:r>
            <a:r>
              <a:rPr lang="en-GB" sz="11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GB" sz="1100" dirty="0" smtClean="0">
                <a:latin typeface="Arial" pitchFamily="34" charset="0"/>
                <a:cs typeface="Arial" pitchFamily="34" charset="0"/>
              </a:rPr>
              <a:t>D-PS were identified as described in Suppl. Table 2 and VPA affected genes (T-genes) were identified as described in Suppl. Table 3. The overlap of up-regulated T-genes with up- (red) and down- (blue) regulated D-PS as well as the overlap of down-regulated T-genes with up- and down-regulated D-PS was calculated for all three cell lines. The data are expressed as the fraction of D-PS affected by VPA.</a:t>
            </a:r>
            <a:endParaRPr lang="en-US" sz="11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8139" y="762000"/>
            <a:ext cx="4485521" cy="314123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93462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6</Words>
  <Application>Microsoft Office PowerPoint</Application>
  <PresentationFormat>Bildschirmpräsentation (4:3)</PresentationFormat>
  <Paragraphs>18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Office Them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Sachinidis</cp:lastModifiedBy>
  <cp:revision>1766</cp:revision>
  <cp:lastPrinted>2016-02-16T08:51:05Z</cp:lastPrinted>
  <dcterms:created xsi:type="dcterms:W3CDTF">2015-04-14T16:22:30Z</dcterms:created>
  <dcterms:modified xsi:type="dcterms:W3CDTF">2016-08-22T11:54:43Z</dcterms:modified>
</cp:coreProperties>
</file>